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C812F6-9801-B906-37F6-3C0CB8D6BC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D2EFFD4-B12E-E232-A80B-B0248F634C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7546FD-6262-5A95-293C-368CA04C4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0D2D5A-7BEF-7819-A320-ED88074E4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AECAF-D5F2-215E-1F11-B2C8D375E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5857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97E55B-47E6-D13A-F945-4CD4773CFB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E7EC52-79D0-8D09-5F03-E3E0FB89AD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49923E-E90F-C7AE-85FA-4F8FD3F59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18DD0E-6191-483A-BE44-A181196A6E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0CD22D-5EFA-4D48-61DB-975726916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1811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8D6A6C6-F730-9B65-9AFE-6460192662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6D0844-C253-D8B3-2C5C-BCAE34D3A1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44EFEA-6125-6662-8DA4-325334AB0D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6B6F27-5F2A-28F1-4822-B96D8A005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C1977F-548F-A787-61D1-CCA63E81B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2810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15D87-2B78-5596-3521-35D7CAA9E0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EF19F1-196C-9EA6-A8EC-293DE51825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83556A-EF17-9F4E-E457-052634DFB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01173E-CECC-D84E-FE09-F433EF4B0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B2BDF3-313F-B2E9-CA66-3DCE4AC96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520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C0250F-BD18-8E16-B07B-2CFED94A19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8829A7-AA48-FB55-07BC-AAE90D37A3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1EA5F1-3E83-7CE6-05D6-0FDB95409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52D84D-6153-EA63-389B-A26229A17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B6AE36-C375-4244-B430-2940025226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649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70966B-5759-5339-3C88-1FC5E7BF75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A47C4C-1712-3226-FBFF-131C8CBE20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2B85D0-009E-C2E6-E1A6-370688D962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C85008-B12B-AE0A-C593-DB7C2DE3C6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EF4857-1822-2204-3434-3067289EF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ADBEB4-76B4-9465-61C8-28F81DE85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3015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3B23E9-F029-98FB-0B1E-B8417B9D49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AD6212-B4F8-82A4-7396-B8F4A8D32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6D01D2-0F89-2DDE-41FB-B78E90CE0A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94A3D6-7361-1BE1-F10C-9045D472B7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393BBD8-4310-1DEC-081F-7DF1469BD7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7B4ACC-5EFB-14D4-61C3-E973BC4AE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4A21A83-6737-580E-5D72-66A30B8069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BCD9782-403C-2586-480A-CD08845C5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8859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6A87B-A103-5163-F747-C5C7B08C5D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B88340-0A38-1FB1-B1E0-44E4A7422D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E17860-6DAC-03C1-358C-2EAF3F54B3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37B234-2FFB-C1B3-D9D5-B66FA4405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2071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727AF13-56B0-1533-4FBB-BEEA22237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7211B4-49A4-0B4D-0562-10C8FC74E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ACA5775-7056-1481-5DEA-D23C1787B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0598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18EA3-79DC-5F79-E37D-6CEFF3E7C8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57B2CC-9144-7AD0-1AE6-2533F9F44F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837B3A-79A0-522E-EBE0-C7C925B609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1EB505-435A-CF7A-1293-1FEF59823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293B59-473E-BEF2-34AB-69D565B03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A66E40-74C4-D535-0589-42670693B6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197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358209-7297-EB0B-B73A-4B499BF426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E2AFA0B-89B2-6B6B-7776-B94EC7BAE3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7674B2-5D3A-7FC7-18A2-F08C8CB985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D287E8-EB49-620A-C238-7C9994EC3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64FB38-C287-7A3E-959A-630BD6B9A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EA28E9-EC25-6370-298C-521ED5281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9305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0354CCB-9F33-562D-508D-A1A0DDE44F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049567-2AB8-D87A-F3F7-57083C78C7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3DC797-CBFF-C42B-768A-3B9B5A1E82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321097-159F-4DDD-AE55-D57FF9C2F167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626900-3AA3-F021-75E3-46F82BCF15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0A0B48-79CF-FA8A-3096-AC52ED44C9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E0B8D05-0B0C-404B-B379-40DFC7F971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6690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DC50475-6B6A-6474-336D-76912FCA97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8408" y="1389574"/>
            <a:ext cx="5040000" cy="445581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0ECE733-E194-D928-5F65-236E6A10FBE2}"/>
              </a:ext>
            </a:extLst>
          </p:cNvPr>
          <p:cNvSpPr txBox="1"/>
          <p:nvPr/>
        </p:nvSpPr>
        <p:spPr>
          <a:xfrm>
            <a:off x="1448961" y="650910"/>
            <a:ext cx="6588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CA2993F-E16B-3D3A-08E1-A621F4E343E6}"/>
              </a:ext>
            </a:extLst>
          </p:cNvPr>
          <p:cNvSpPr txBox="1"/>
          <p:nvPr/>
        </p:nvSpPr>
        <p:spPr>
          <a:xfrm>
            <a:off x="2437308" y="1020242"/>
            <a:ext cx="1135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CDi</a:t>
            </a:r>
            <a:r>
              <a:rPr lang="en-GB" dirty="0"/>
              <a:t> PR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FB0F2B8-0675-E165-2A62-2A3AB230705C}"/>
              </a:ext>
            </a:extLst>
          </p:cNvPr>
          <p:cNvSpPr txBox="1"/>
          <p:nvPr/>
        </p:nvSpPr>
        <p:spPr>
          <a:xfrm>
            <a:off x="4806746" y="5910253"/>
            <a:ext cx="1362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ehicle PRE</a:t>
            </a:r>
          </a:p>
        </p:txBody>
      </p:sp>
    </p:spTree>
    <p:extLst>
      <p:ext uri="{BB962C8B-B14F-4D97-AF65-F5344CB8AC3E}">
        <p14:creationId xmlns:p14="http://schemas.microsoft.com/office/powerpoint/2010/main" val="34329170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0ECE733-E194-D928-5F65-236E6A10FBE2}"/>
              </a:ext>
            </a:extLst>
          </p:cNvPr>
          <p:cNvSpPr txBox="1"/>
          <p:nvPr/>
        </p:nvSpPr>
        <p:spPr>
          <a:xfrm>
            <a:off x="1448961" y="650910"/>
            <a:ext cx="6588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CA2993F-E16B-3D3A-08E1-A621F4E343E6}"/>
              </a:ext>
            </a:extLst>
          </p:cNvPr>
          <p:cNvSpPr txBox="1"/>
          <p:nvPr/>
        </p:nvSpPr>
        <p:spPr>
          <a:xfrm>
            <a:off x="2437308" y="1020242"/>
            <a:ext cx="1135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CDi</a:t>
            </a:r>
            <a:r>
              <a:rPr lang="en-GB" dirty="0"/>
              <a:t> PR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FB0F2B8-0675-E165-2A62-2A3AB230705C}"/>
              </a:ext>
            </a:extLst>
          </p:cNvPr>
          <p:cNvSpPr txBox="1"/>
          <p:nvPr/>
        </p:nvSpPr>
        <p:spPr>
          <a:xfrm>
            <a:off x="4934565" y="5859355"/>
            <a:ext cx="1362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ehicle PR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4F0A733-FED1-E966-A283-3A20A3832E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9022" y="1389574"/>
            <a:ext cx="5040000" cy="4469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07786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0ECE733-E194-D928-5F65-236E6A10FBE2}"/>
              </a:ext>
            </a:extLst>
          </p:cNvPr>
          <p:cNvSpPr txBox="1"/>
          <p:nvPr/>
        </p:nvSpPr>
        <p:spPr>
          <a:xfrm>
            <a:off x="1448961" y="650910"/>
            <a:ext cx="6588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CA2993F-E16B-3D3A-08E1-A621F4E343E6}"/>
              </a:ext>
            </a:extLst>
          </p:cNvPr>
          <p:cNvSpPr txBox="1"/>
          <p:nvPr/>
        </p:nvSpPr>
        <p:spPr>
          <a:xfrm>
            <a:off x="2437308" y="1020242"/>
            <a:ext cx="1135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CDi</a:t>
            </a:r>
            <a:r>
              <a:rPr lang="en-GB" dirty="0"/>
              <a:t> PR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FB0F2B8-0675-E165-2A62-2A3AB230705C}"/>
              </a:ext>
            </a:extLst>
          </p:cNvPr>
          <p:cNvSpPr txBox="1"/>
          <p:nvPr/>
        </p:nvSpPr>
        <p:spPr>
          <a:xfrm>
            <a:off x="4802145" y="5770868"/>
            <a:ext cx="1362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ehicle PR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C809CFE-EB20-560F-EF0A-DD2EEDD8C2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3424" y="1345330"/>
            <a:ext cx="5040000" cy="4469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28981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0ECE733-E194-D928-5F65-236E6A10FBE2}"/>
              </a:ext>
            </a:extLst>
          </p:cNvPr>
          <p:cNvSpPr txBox="1"/>
          <p:nvPr/>
        </p:nvSpPr>
        <p:spPr>
          <a:xfrm>
            <a:off x="1448961" y="650910"/>
            <a:ext cx="6588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CA2993F-E16B-3D3A-08E1-A621F4E343E6}"/>
              </a:ext>
            </a:extLst>
          </p:cNvPr>
          <p:cNvSpPr txBox="1"/>
          <p:nvPr/>
        </p:nvSpPr>
        <p:spPr>
          <a:xfrm>
            <a:off x="2437308" y="1020242"/>
            <a:ext cx="1135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CDi</a:t>
            </a:r>
            <a:r>
              <a:rPr lang="en-GB" dirty="0"/>
              <a:t> PR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FB0F2B8-0675-E165-2A62-2A3AB230705C}"/>
              </a:ext>
            </a:extLst>
          </p:cNvPr>
          <p:cNvSpPr txBox="1"/>
          <p:nvPr/>
        </p:nvSpPr>
        <p:spPr>
          <a:xfrm>
            <a:off x="4865741" y="5969250"/>
            <a:ext cx="1362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ehicle PRE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22D38E9C-D974-F605-9AEE-C5399E8A37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6397" y="1389574"/>
            <a:ext cx="5040000" cy="4470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1078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0</Words>
  <Application>Microsoft Office PowerPoint</Application>
  <PresentationFormat>Widescreen</PresentationFormat>
  <Paragraphs>1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1</cp:revision>
  <dcterms:created xsi:type="dcterms:W3CDTF">2024-06-18T16:46:57Z</dcterms:created>
  <dcterms:modified xsi:type="dcterms:W3CDTF">2024-06-18T16:54:33Z</dcterms:modified>
</cp:coreProperties>
</file>